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0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24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5F65C-5FEB-FE48-6352-3591289918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9251F0-E668-67DC-F09E-DD79C78BE4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02D92E-9C45-F63C-925B-FF20F0EFB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ED3C2A-32DC-0F9F-9E07-6FFDBE808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849C0B-D5A6-7159-A81A-753CC6FB7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8413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9C7185-D392-0C0B-BAF5-E033E9D341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026C59-9423-6B48-395D-8688A64A6D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6B9F35-03D7-0967-3BAD-CBCBE8062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ADEC77-5E17-2E25-46B1-B99D9AAB2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9A534F-84BA-C474-3D6E-8535432F62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5381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01F473C-878C-5A52-3C9C-DED63C6E9E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08E00E-1F84-FB80-FCB5-AEC45B12B8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A37DE2-224E-F788-514C-B70E79B90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D24CA6-D744-18C6-421D-2A24040DE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F8C294-1489-B923-6891-88591719B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2623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4395C1-7B9E-B86B-286D-69366BA90E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AB0011-BE9E-3C66-DE5F-228F1E6C32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3FD799-0797-D03C-08A6-42E239AF1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358CDA-0297-6259-D29A-F93A5C9BF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E6F429-AF15-9B61-08DE-7A81B67B5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1107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500114-079F-8BAC-776F-A4825C6D3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CA86C5-5197-6A27-66F4-87FD1E7188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39DF15-E194-FE5C-3984-66750EC45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9401D2-0C99-2CE1-3A85-BF80B0211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394329-B824-2E93-7CBE-4FEB8BB0FE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942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B380F2-1CAF-6BD7-DB35-0A7E263F53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888B5F-1A15-3509-D632-D541880B21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6EE008-AF4E-9C98-2122-99DC7A8379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BCE61A-FC6D-D1F0-92E0-FCDFD3FCB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A4E00B-377F-B896-6DC6-104F499E9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A3DC53-CDF4-DA5E-7375-164EBBFC3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174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DB9F99-AB72-D59D-61DC-895ED5BD45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F1A856-DAD8-3141-7194-5A0E14C803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609520-2948-9FCF-368A-EC80CE13B5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A46224-7EBE-FA8A-87A6-E12FF071C1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F0BCD7-D36F-0217-ADDB-97DEB5B4E1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3CCCC2-C0C2-1F63-DE4A-0849BD942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25D8AC-6483-A05D-EF9E-35D569523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CAE480-3912-F8AB-D159-B95A883E5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872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080894-CDD2-418D-80CA-1FA0047926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6B5B03-53F9-189C-6A8B-F357271AC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E24582B-67E0-E92F-BC02-1C44144E1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E4AB9F-83AF-0490-C985-901781E5F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629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55F46A-9483-808E-66E7-B18EF08D6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23D5C1-6DAC-304A-EA61-B9511BF52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3F6709-989D-6CDB-602A-52DD608BB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3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362F62-B1EA-A2E5-D9AC-CB4BBFC904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317D99-149C-12AA-4F2D-C3546DEF72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E4D80B-A9BC-0756-2627-9DC92992C2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082401-BC9A-633D-3C3E-70710090A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BBECA9-460D-A2DB-4417-B90220BB2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C7AD4D-9E39-C78F-586C-6B3F0905D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395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DD3CBF-52E3-74FA-8C02-8216A9F607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AA0254-F42A-F0EB-D096-C8FDD5BE29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CC981E-3754-29CE-1F95-0A52A4CABA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646515-6096-6D0C-6830-ADF0915DD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322C07-C28D-D93A-1C9D-77FB269CB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FE0203-C29A-A27C-0F6B-E635E3C93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639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1DF73F-8DBE-DF3F-56EB-7D233AD9D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FF2DD6-93D7-8BDE-4AD6-076FAB9D67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AAB500-3A41-921B-69BC-DE26D79B14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2B433-7529-4869-B9F2-5659BFB7331E}" type="datetimeFigureOut">
              <a:rPr lang="de-DE" smtClean="0"/>
              <a:t>06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A8B774-054C-FC46-F3B9-9FA464C054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4D14C2-1922-9576-94BE-92AD58B522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041524-29E4-44B4-8248-E724E05E147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1680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4498AB31-CD47-B3B5-EC0B-C9BA90BB9608}"/>
              </a:ext>
            </a:extLst>
          </p:cNvPr>
          <p:cNvGrpSpPr/>
          <p:nvPr/>
        </p:nvGrpSpPr>
        <p:grpSpPr>
          <a:xfrm>
            <a:off x="3031757" y="298471"/>
            <a:ext cx="5423102" cy="4827186"/>
            <a:chOff x="1250582" y="22246"/>
            <a:chExt cx="5423102" cy="4827186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C694ED47-0301-EB2B-9A41-CB0D524BBA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12587" y="2439124"/>
              <a:ext cx="1440000" cy="144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B6817A7-2230-45FC-483D-92E1A88CC5A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11770" y="757473"/>
              <a:ext cx="1440000" cy="144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9A62DC7-D6C2-0D40-83D1-41A7F69346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73442" y="757473"/>
              <a:ext cx="1440000" cy="14400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2B62A00-A548-C722-85E4-158BA0C871F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81841" y="2434528"/>
              <a:ext cx="1440000" cy="14400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799FEC6F-18FB-D39E-515F-C0A7417D85A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64267" y="22246"/>
              <a:ext cx="1440000" cy="14400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F7B38899-D06B-86B9-2733-ABB30D16859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964267" y="1597046"/>
              <a:ext cx="1440000" cy="14400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3D121FD0-585A-2680-05B0-DEBA6FC8EC3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964267" y="3171846"/>
              <a:ext cx="1440000" cy="144000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BB5A656-E5A6-78BD-42FE-63A62468E431}"/>
                </a:ext>
              </a:extLst>
            </p:cNvPr>
            <p:cNvSpPr txBox="1"/>
            <p:nvPr/>
          </p:nvSpPr>
          <p:spPr>
            <a:xfrm>
              <a:off x="1900589" y="2193773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CD203c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E1E06A5-E32B-30BB-5282-17378E325C5F}"/>
                </a:ext>
              </a:extLst>
            </p:cNvPr>
            <p:cNvSpPr txBox="1"/>
            <p:nvPr/>
          </p:nvSpPr>
          <p:spPr>
            <a:xfrm rot="16200000">
              <a:off x="1081401" y="1263498"/>
              <a:ext cx="615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/>
                <a:t>Fc</a:t>
              </a:r>
              <a:r>
                <a:rPr lang="de-DE" sz="1200" dirty="0" err="1">
                  <a:latin typeface="Symbol" panose="05050102010706020507" pitchFamily="18" charset="2"/>
                </a:rPr>
                <a:t>e</a:t>
              </a:r>
              <a:r>
                <a:rPr lang="de-DE" sz="1200" dirty="0" err="1"/>
                <a:t>RI</a:t>
              </a:r>
              <a:r>
                <a:rPr lang="de-DE" sz="1200" dirty="0" err="1">
                  <a:latin typeface="Symbol" panose="05050102010706020507" pitchFamily="18" charset="2"/>
                </a:rPr>
                <a:t>a</a:t>
              </a:r>
              <a:endParaRPr lang="de-DE" sz="1200" dirty="0">
                <a:latin typeface="Symbol" panose="05050102010706020507" pitchFamily="18" charset="2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684DD73-988E-7079-4F74-BEF2A5047877}"/>
                </a:ext>
              </a:extLst>
            </p:cNvPr>
            <p:cNvSpPr txBox="1"/>
            <p:nvPr/>
          </p:nvSpPr>
          <p:spPr>
            <a:xfrm>
              <a:off x="3582019" y="2193773"/>
              <a:ext cx="5415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FSC-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584CBD6-523B-6E4D-7F83-7CA15A001574}"/>
                </a:ext>
              </a:extLst>
            </p:cNvPr>
            <p:cNvSpPr txBox="1"/>
            <p:nvPr/>
          </p:nvSpPr>
          <p:spPr>
            <a:xfrm rot="16200000">
              <a:off x="2798642" y="1263498"/>
              <a:ext cx="543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SSC-A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8BDD214-3F1E-073D-1D72-D4636814E6F0}"/>
                </a:ext>
              </a:extLst>
            </p:cNvPr>
            <p:cNvSpPr txBox="1"/>
            <p:nvPr/>
          </p:nvSpPr>
          <p:spPr>
            <a:xfrm>
              <a:off x="1900586" y="3879778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CD203c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F8FCFB8-847B-AA07-8E4B-B642198647F6}"/>
                </a:ext>
              </a:extLst>
            </p:cNvPr>
            <p:cNvSpPr txBox="1"/>
            <p:nvPr/>
          </p:nvSpPr>
          <p:spPr>
            <a:xfrm rot="16200000">
              <a:off x="567382" y="2949503"/>
              <a:ext cx="16433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BP530/30 (AF-Channel)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A3B9E6B-BDA4-444A-48FF-88C1256F289B}"/>
                </a:ext>
              </a:extLst>
            </p:cNvPr>
            <p:cNvSpPr txBox="1"/>
            <p:nvPr/>
          </p:nvSpPr>
          <p:spPr>
            <a:xfrm>
              <a:off x="3587825" y="3874528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CD203c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D71BA66-B947-E955-61DD-3EFFBE549CB5}"/>
                </a:ext>
              </a:extLst>
            </p:cNvPr>
            <p:cNvSpPr txBox="1"/>
            <p:nvPr/>
          </p:nvSpPr>
          <p:spPr>
            <a:xfrm rot="16200000">
              <a:off x="2781207" y="2944253"/>
              <a:ext cx="5902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SSC-W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1A9E154-0735-D732-8A38-0230601833D9}"/>
                </a:ext>
              </a:extLst>
            </p:cNvPr>
            <p:cNvSpPr txBox="1"/>
            <p:nvPr/>
          </p:nvSpPr>
          <p:spPr>
            <a:xfrm>
              <a:off x="5345168" y="4572433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CD203c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9D0204D-940D-9F35-FE49-4A7A872D7A82}"/>
                </a:ext>
              </a:extLst>
            </p:cNvPr>
            <p:cNvSpPr txBox="1"/>
            <p:nvPr/>
          </p:nvSpPr>
          <p:spPr>
            <a:xfrm rot="16200000">
              <a:off x="4480997" y="2054436"/>
              <a:ext cx="518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CD63</a:t>
              </a: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A9A0553B-802C-7E0C-9223-1E50F4176530}"/>
                </a:ext>
              </a:extLst>
            </p:cNvPr>
            <p:cNvCxnSpPr/>
            <p:nvPr/>
          </p:nvCxnSpPr>
          <p:spPr>
            <a:xfrm flipV="1">
              <a:off x="4837938" y="22246"/>
              <a:ext cx="0" cy="455018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D8DE945A-2F1F-7967-BB37-AEF0AC7B6983}"/>
                </a:ext>
              </a:extLst>
            </p:cNvPr>
            <p:cNvCxnSpPr>
              <a:cxnSpLocks/>
            </p:cNvCxnSpPr>
            <p:nvPr/>
          </p:nvCxnSpPr>
          <p:spPr>
            <a:xfrm>
              <a:off x="2790343" y="1105988"/>
              <a:ext cx="60087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230BC133-BBD8-C4A6-E36F-98161F527C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32012" y="1340644"/>
              <a:ext cx="801788" cy="109388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F40B866B-8B61-3DB8-3B20-6B745B7A8B51}"/>
                </a:ext>
              </a:extLst>
            </p:cNvPr>
            <p:cNvCxnSpPr>
              <a:cxnSpLocks/>
            </p:cNvCxnSpPr>
            <p:nvPr/>
          </p:nvCxnSpPr>
          <p:spPr>
            <a:xfrm>
              <a:off x="2627791" y="3574304"/>
              <a:ext cx="960034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3B3494FA-96DD-AA59-78EB-D6306C4E0A1D}"/>
                </a:ext>
              </a:extLst>
            </p:cNvPr>
            <p:cNvCxnSpPr>
              <a:cxnSpLocks/>
            </p:cNvCxnSpPr>
            <p:nvPr/>
          </p:nvCxnSpPr>
          <p:spPr>
            <a:xfrm>
              <a:off x="4353178" y="3377866"/>
              <a:ext cx="382121" cy="0"/>
            </a:xfrm>
            <a:prstGeom prst="straightConnector1">
              <a:avLst/>
            </a:prstGeom>
            <a:ln w="25400" cmpd="dbl">
              <a:solidFill>
                <a:schemeClr val="tx1"/>
              </a:solidFill>
              <a:tailEnd type="stealth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C4F9869-A669-4BD8-011F-8D4B3ABF75C9}"/>
                </a:ext>
              </a:extLst>
            </p:cNvPr>
            <p:cNvSpPr txBox="1"/>
            <p:nvPr/>
          </p:nvSpPr>
          <p:spPr>
            <a:xfrm rot="16200000">
              <a:off x="6081593" y="512132"/>
              <a:ext cx="8980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/>
                <a:t>fMLP</a:t>
              </a:r>
              <a:r>
                <a:rPr lang="de-DE" sz="1200" dirty="0"/>
                <a:t> </a:t>
              </a:r>
              <a:r>
                <a:rPr lang="de-DE" sz="800" dirty="0"/>
                <a:t>(0.1 µM)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BCCA47A-1D62-D13A-99DD-92E4673B4015}"/>
                </a:ext>
              </a:extLst>
            </p:cNvPr>
            <p:cNvSpPr txBox="1"/>
            <p:nvPr/>
          </p:nvSpPr>
          <p:spPr>
            <a:xfrm rot="16200000">
              <a:off x="6325833" y="2133839"/>
              <a:ext cx="4187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PBS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51696C5-EA0A-2104-C9E8-7325EEA20CC7}"/>
                </a:ext>
              </a:extLst>
            </p:cNvPr>
            <p:cNvSpPr txBox="1"/>
            <p:nvPr/>
          </p:nvSpPr>
          <p:spPr>
            <a:xfrm rot="16200000">
              <a:off x="5726531" y="3693398"/>
              <a:ext cx="1608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/>
                <a:t>rPru</a:t>
              </a:r>
              <a:r>
                <a:rPr lang="de-DE" sz="1200" dirty="0"/>
                <a:t> p 3 </a:t>
              </a:r>
              <a:r>
                <a:rPr lang="de-DE" sz="800" dirty="0"/>
                <a:t>(1 µg/ml : </a:t>
              </a:r>
              <a:r>
                <a:rPr lang="de-DE" sz="800" dirty="0" err="1"/>
                <a:t>lipid</a:t>
              </a:r>
              <a:r>
                <a:rPr lang="de-DE" sz="800" dirty="0"/>
                <a:t> 1:100)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B0420FB4-9FE3-83CB-DCFD-4F4602040FD7}"/>
              </a:ext>
            </a:extLst>
          </p:cNvPr>
          <p:cNvSpPr txBox="1"/>
          <p:nvPr/>
        </p:nvSpPr>
        <p:spPr>
          <a:xfrm>
            <a:off x="2647430" y="5258881"/>
            <a:ext cx="567217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Fig. S1. </a:t>
            </a:r>
            <a:r>
              <a:rPr lang="en-US" sz="1200"/>
              <a:t>The </a:t>
            </a:r>
            <a:r>
              <a:rPr lang="en-US" sz="1200" dirty="0"/>
              <a:t>basophil activation test (BAT) was performed using a stepwise hierarchical gating strategy. First, CD203c⁺/</a:t>
            </a:r>
            <a:r>
              <a:rPr lang="en-US" sz="1200" dirty="0" err="1"/>
              <a:t>FcεRI</a:t>
            </a:r>
            <a:r>
              <a:rPr lang="en-US" sz="1200" dirty="0"/>
              <a:t>α⁺ events were selected. Second, larger cells (e.g., dendritic cells) were excluded based on FSC-A/SSC-A characteristics. Third, cells with high autofluorescence were excluded using the FITC channel (BP 530/30). Fourth, doublets were excluded, defining the final basophil analysis gate. Basophils were analyzed for CD63 expression (%) and median CD203c expression, based on events within the upper right and lower right quadrants (used for Figure 4).</a:t>
            </a:r>
            <a:endParaRPr lang="de-DE" sz="1200" baseline="30000" dirty="0"/>
          </a:p>
        </p:txBody>
      </p:sp>
    </p:spTree>
    <p:extLst>
      <p:ext uri="{BB962C8B-B14F-4D97-AF65-F5344CB8AC3E}">
        <p14:creationId xmlns:p14="http://schemas.microsoft.com/office/powerpoint/2010/main" val="3373235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1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re</dc:creator>
  <cp:lastModifiedBy>Abu Risha</cp:lastModifiedBy>
  <cp:revision>7</cp:revision>
  <cp:lastPrinted>2026-04-07T09:38:09Z</cp:lastPrinted>
  <dcterms:created xsi:type="dcterms:W3CDTF">2026-04-07T09:38:06Z</dcterms:created>
  <dcterms:modified xsi:type="dcterms:W3CDTF">2026-05-06T08:45:54Z</dcterms:modified>
</cp:coreProperties>
</file>